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502400" cy="65024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0" y="0"/>
            <a:ext cx="6502400" cy="6502400"/>
          </a:xfrm>
          <a:prstGeom prst="rect">
            <a:avLst/>
          </a:prstGeom>
        </p:spPr>
      </p:pic>
      <p:sp>
        <p:nvSpPr>
          <p:cNvPr id="4" name="textbox 4"/>
          <p:cNvSpPr/>
          <p:nvPr/>
        </p:nvSpPr>
        <p:spPr>
          <a:xfrm>
            <a:off x="292132" y="295627"/>
            <a:ext cx="5974079" cy="306070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9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040130" indent="-1028065" algn="l" rtl="0" eaLnBrk="0">
              <a:lnSpc>
                <a:spcPct val="107000"/>
              </a:lnSpc>
            </a:pPr>
            <a:r>
              <a:rPr sz="1500" b="1" kern="0" spc="-4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axative effect of Zengye granule via modulation of SCF/c-kit </a:t>
            </a:r>
            <a:r>
              <a:rPr sz="1500" kern="0" spc="-4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athway</a:t>
            </a:r>
            <a:r>
              <a:rPr sz="1500" kern="0" spc="2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4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d gut</a:t>
            </a:r>
            <a:r>
              <a:rPr sz="1500" b="1" kern="0" spc="8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4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icrobiota</a:t>
            </a:r>
            <a:r>
              <a:rPr sz="1500" b="1" kern="0" spc="9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4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n constipated model</a:t>
            </a:r>
            <a:r>
              <a:rPr sz="1500" b="1" kern="0" spc="7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50" dirty="0">
                <a:solidFill>
                  <a:srgbClr val="D0A01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ice</a:t>
            </a:r>
            <a:endParaRPr sz="15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06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06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06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06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07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07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602615" algn="l" rtl="0" eaLnBrk="0">
              <a:lnSpc>
                <a:spcPct val="77000"/>
              </a:lnSpc>
              <a:spcBef>
                <a:spcPts val="300"/>
              </a:spcBef>
            </a:pPr>
            <a:r>
              <a:rPr sz="1000" b="1" kern="0" spc="0" dirty="0">
                <a:solidFill>
                  <a:srgbClr val="FFFFFF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ZYG modulates g</a:t>
            </a:r>
            <a:r>
              <a:rPr sz="1000" b="1" kern="0" spc="-10" dirty="0">
                <a:solidFill>
                  <a:srgbClr val="FFFFFF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ut microbiota:decreases Firmicutes,</a:t>
            </a:r>
            <a:endParaRPr sz="10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  <a:p>
            <a:pPr marL="1034415" algn="l" rtl="0" eaLnBrk="0">
              <a:lnSpc>
                <a:spcPct val="77000"/>
              </a:lnSpc>
              <a:spcBef>
                <a:spcPts val="275"/>
              </a:spcBef>
            </a:pPr>
            <a:r>
              <a:rPr sz="1000" b="1" kern="0" spc="0" dirty="0">
                <a:solidFill>
                  <a:srgbClr val="FFFFFF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increases Bacteroidetes </a:t>
            </a:r>
            <a:r>
              <a:rPr sz="1000" b="1" kern="0" spc="-10" dirty="0">
                <a:solidFill>
                  <a:srgbClr val="FFFFFF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at genus level</a:t>
            </a:r>
            <a:endParaRPr sz="10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  <a:p>
            <a:pPr algn="l" rtl="0" eaLnBrk="0">
              <a:lnSpc>
                <a:spcPct val="130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30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354965" algn="l" rtl="0" eaLnBrk="0">
              <a:lnSpc>
                <a:spcPct val="77000"/>
              </a:lnSpc>
              <a:spcBef>
                <a:spcPts val="305"/>
              </a:spcBef>
            </a:pPr>
            <a:r>
              <a:rPr lang="en-US" sz="1000" b="1" kern="0" spc="0" dirty="0">
                <a:solidFill>
                  <a:srgbClr val="D0704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Modulate</a:t>
            </a:r>
            <a:r>
              <a:rPr sz="1000" b="1" kern="0" spc="0" dirty="0">
                <a:solidFill>
                  <a:srgbClr val="D0704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SCF/c-Kit signaling pathway</a:t>
            </a:r>
            <a:r>
              <a:rPr sz="1000" b="1" kern="0" spc="-10" dirty="0">
                <a:solidFill>
                  <a:srgbClr val="D0704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to enhance</a:t>
            </a:r>
            <a:endParaRPr sz="10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  <a:p>
            <a:pPr marL="710565" algn="l" rtl="0" eaLnBrk="0">
              <a:lnSpc>
                <a:spcPct val="77000"/>
              </a:lnSpc>
              <a:spcBef>
                <a:spcPts val="275"/>
              </a:spcBef>
            </a:pPr>
            <a:r>
              <a:rPr sz="1000" b="1" kern="0" spc="0" dirty="0">
                <a:solidFill>
                  <a:srgbClr val="D0603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intestinal m</a:t>
            </a:r>
            <a:r>
              <a:rPr sz="1000" b="1" kern="0" spc="-10" dirty="0">
                <a:solidFill>
                  <a:srgbClr val="D0603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otility and mucosal</a:t>
            </a:r>
            <a:r>
              <a:rPr sz="1000" b="1" kern="0" spc="30" dirty="0">
                <a:solidFill>
                  <a:srgbClr val="D0603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000" b="1" kern="0" spc="-10" dirty="0">
                <a:solidFill>
                  <a:srgbClr val="D0603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repair</a:t>
            </a:r>
            <a:endParaRPr sz="10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  <a:p>
            <a:pPr algn="l" rtl="0" eaLnBrk="0">
              <a:lnSpc>
                <a:spcPct val="131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27965" algn="l" rtl="0" eaLnBrk="0">
              <a:lnSpc>
                <a:spcPts val="1360"/>
              </a:lnSpc>
              <a:spcBef>
                <a:spcPts val="305"/>
              </a:spcBef>
            </a:pPr>
            <a:r>
              <a:rPr sz="1000" kern="0" spc="-20" dirty="0">
                <a:solidFill>
                  <a:srgbClr val="10C0E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egulates neurotransmitters and reduce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47015" algn="l" rtl="0" eaLnBrk="0">
              <a:lnSpc>
                <a:spcPct val="79000"/>
              </a:lnSpc>
              <a:spcBef>
                <a:spcPts val="210"/>
              </a:spcBef>
            </a:pPr>
            <a:r>
              <a:rPr sz="1000" kern="0" spc="0" dirty="0">
                <a:solidFill>
                  <a:srgbClr val="20C0D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pro-inflammatory     cytokines(IL-6,TN</a:t>
            </a:r>
            <a:r>
              <a:rPr sz="1000" kern="0" spc="-10" dirty="0">
                <a:solidFill>
                  <a:srgbClr val="20C0D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F-α)</a:t>
            </a:r>
            <a:endParaRPr sz="10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</p:txBody>
      </p:sp>
      <p:pic>
        <p:nvPicPr>
          <p:cNvPr id="6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209572" y="4032268"/>
            <a:ext cx="2908263" cy="2019255"/>
          </a:xfrm>
          <a:prstGeom prst="rect">
            <a:avLst/>
          </a:prstGeom>
        </p:spPr>
      </p:pic>
      <p:pic>
        <p:nvPicPr>
          <p:cNvPr id="3" name="图片 2" descr="图片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5930" y="5598160"/>
            <a:ext cx="810260" cy="741045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3942715" y="5843905"/>
            <a:ext cx="1725295" cy="337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000" b="1"/>
              <a:t>ZYG </a:t>
            </a:r>
            <a:endParaRPr lang="en-US" altLang="zh-CN" sz="1000" b="1"/>
          </a:p>
          <a:p>
            <a:pPr algn="ctr"/>
            <a:r>
              <a:rPr lang="en-US" altLang="zh-CN" sz="1000" b="1"/>
              <a:t>oral administration</a:t>
            </a:r>
            <a:endParaRPr lang="en-US" altLang="zh-CN" sz="1000" b="1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2</Words>
  <Application>WPS 演示</Application>
  <PresentationFormat/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Arial</vt:lpstr>
      <vt:lpstr>Times New Roman</vt:lpstr>
      <vt:lpstr>微软雅黑</vt:lpstr>
      <vt:lpstr>Arial Unicode MS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吕凤霞</cp:lastModifiedBy>
  <cp:revision>4</cp:revision>
  <dcterms:created xsi:type="dcterms:W3CDTF">2025-05-11T09:30:00Z</dcterms:created>
  <dcterms:modified xsi:type="dcterms:W3CDTF">2025-05-11T09:50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ExMEI</vt:lpwstr>
  </property>
  <property fmtid="{D5CDD505-2E9C-101B-9397-08002B2CF9AE}" pid="3" name="Created">
    <vt:filetime>2025-05-12T01:27:05Z</vt:filetime>
  </property>
  <property fmtid="{D5CDD505-2E9C-101B-9397-08002B2CF9AE}" pid="4" name="UsrData">
    <vt:lpwstr>68206d671c4bf3001f1a8f63wl</vt:lpwstr>
  </property>
  <property fmtid="{D5CDD505-2E9C-101B-9397-08002B2CF9AE}" pid="5" name="ICV">
    <vt:lpwstr>3F9DA0785D93402882C8B71818F3515D_12</vt:lpwstr>
  </property>
  <property fmtid="{D5CDD505-2E9C-101B-9397-08002B2CF9AE}" pid="6" name="KSOProductBuildVer">
    <vt:lpwstr>2052-12.1.0.21171</vt:lpwstr>
  </property>
</Properties>
</file>